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602" y="-15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92249" y="476672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S6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|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Bodyweight at birth in first generation. 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8" name="Tableau 7"/>
          <p:cNvGraphicFramePr>
            <a:graphicFrameLocks noGrp="1"/>
          </p:cNvGraphicFramePr>
          <p:nvPr/>
        </p:nvGraphicFramePr>
        <p:xfrm>
          <a:off x="92250" y="772721"/>
          <a:ext cx="6659999" cy="691532"/>
        </p:xfrm>
        <a:graphic>
          <a:graphicData uri="http://schemas.openxmlformats.org/drawingml/2006/table">
            <a:tbl>
              <a:tblPr/>
              <a:tblGrid>
                <a:gridCol w="1407267"/>
                <a:gridCol w="295053"/>
                <a:gridCol w="295053"/>
                <a:gridCol w="1180211"/>
                <a:gridCol w="1180211"/>
                <a:gridCol w="737632"/>
                <a:gridCol w="958922"/>
                <a:gridCol w="605650"/>
              </a:tblGrid>
              <a:tr h="36932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Variable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Number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of </a:t>
                      </a:r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kits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edian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[Q1; Q3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Adjusted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linear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model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47729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10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β </a:t>
                      </a:r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alue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I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p-value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9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/>
                        </a:rPr>
                        <a:t>Litter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/>
                        </a:rPr>
                        <a:t>weight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/>
                        </a:rPr>
                        <a:t>at</a:t>
                      </a:r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FR" sz="1000" b="0" i="0" u="none" strike="noStrike" dirty="0" err="1" smtClean="0">
                          <a:solidFill>
                            <a:srgbClr val="000000"/>
                          </a:solidFill>
                          <a:latin typeface="Times New Roman"/>
                        </a:rPr>
                        <a:t>birth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5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83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66.25 [58.00; 69.33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54.13 [51.00; 68.00]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8.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16.232;-0.029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06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ZoneTexte 8"/>
          <p:cNvSpPr txBox="1"/>
          <p:nvPr/>
        </p:nvSpPr>
        <p:spPr>
          <a:xfrm>
            <a:off x="92249" y="1483276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All data are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express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median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[Q1;Q3]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9</TotalTime>
  <Words>62</Words>
  <Application>Microsoft Office PowerPoint</Application>
  <PresentationFormat>Affichage à l'écran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N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alentino</dc:creator>
  <cp:lastModifiedBy>Sarah</cp:lastModifiedBy>
  <cp:revision>52</cp:revision>
  <dcterms:created xsi:type="dcterms:W3CDTF">2015-02-24T15:36:47Z</dcterms:created>
  <dcterms:modified xsi:type="dcterms:W3CDTF">2016-02-08T10:30:24Z</dcterms:modified>
</cp:coreProperties>
</file>